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357"/>
    <p:restoredTop sz="90116" autoAdjust="0"/>
  </p:normalViewPr>
  <p:slideViewPr>
    <p:cSldViewPr snapToGrid="0">
      <p:cViewPr varScale="1">
        <p:scale>
          <a:sx n="104" d="100"/>
          <a:sy n="104" d="100"/>
        </p:scale>
        <p:origin x="3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5A3DA-1705-17A4-A4F4-963E9A64F0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41C8C8-54F2-D523-E8B8-67E0F1606C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57E4A-C635-8703-FE4F-285D8A2C8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F25EBC-BB2C-7E68-77E0-A739E9343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568CA4-14C6-0998-FB43-E25C88919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016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6021B-0075-3E75-D15F-4582A40BBC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B30F36-4C4B-A073-880A-83C5344A99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B5481F-7D36-9DDF-3721-985EB86DB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DFF2CA-BA94-D06D-96CB-4AF90373B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EDF41F-9013-74C0-56E4-8EBC91B2F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391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BCEAA6-DB6D-62D9-A9CD-66B8CDAB92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960DDA-DF6C-1FD2-2EB8-B66E5AD2BD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A2C148-8D92-CDB4-5581-FA187FA67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B67C1F-E8D1-3761-E1CA-6D9305C20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790043-248D-749D-2D6B-1EE1A3694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442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FE3356-DB3B-15F8-7234-5BA8B0097F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98146B-8D2E-3802-CF5D-02C098E438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DF929F-42DC-5686-EF99-2C36501D5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7AD8EC-A44B-0205-8D0B-91BD9DD7E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D7DADF-4794-D0A0-0292-1B6F9F0F2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77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AE761-EF6B-271B-4D6B-72E561460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CB77C7-FE26-48A3-C669-C89AE59BCA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1D4465-3438-1A02-E16B-7049C8096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7CD2B0-2E5E-6252-9719-55190223F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293DC9-6872-AE1B-3B61-AD617B0EF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715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7BCC3F-9BC8-BCD7-AF12-2C9BC9D191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0996B7-C402-2AAB-9F10-BFAE1CA3A1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06ED77-DDDE-0B5A-BA72-D483E1F2B8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65B43E-D9CF-6C9A-11CD-31DF05250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A03AA2-0F22-7386-AC20-22199D52F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3013D3-98F0-5DDF-8C11-027107485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73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AA553-9C32-5995-4FD6-742484BD2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DD8A65-D693-572F-D210-5E62EDC88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ADD105-9CD7-8F9E-648E-E96BA00DAD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2FAFA3-1198-D300-093F-CF37DE2302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13E25E-6D28-28F5-085C-0EDF8F8C8F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0CD70B-28E1-4F51-42AA-C834DB80A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ECFDD7-2BE8-D00C-267E-659B9B23C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4A59B4-772A-8629-CD85-34A54892C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086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9A1A1-28BA-A612-CD59-4AF1CF215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3DC54B-FA0B-6327-85A6-4264CA685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269CFA-8D0B-BF94-72EE-C4C92AF1E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AC4AFC-75A1-3375-B9A6-1CA8B148A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9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DDFC01-379E-55B5-8365-EFCFE0B9F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5F5331-FEE9-D0EA-1261-A4D04C454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6E0B7B-52F3-0911-9FE0-42D4C6AF1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370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7E7F9-03D2-64D1-398C-7BD497D0E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A056A5-FD9C-1485-A026-1C60B1D3C0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06AA3A-D243-FED6-75BE-00D878E5D4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47B636-7724-4778-BFEB-8CD5CE70B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5CE45E-8242-D4CD-3822-052984D0D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C36945-BBDA-A8B1-93B2-E0F011A61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437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2A6884-1EB4-4473-1199-7EB508D6A5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A57679-B356-D523-E17E-A6CE2D6EC2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72FE6F-C96D-296D-FD1F-363057A32A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B5F66F-24D5-F0B6-485B-9F806FAA6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99A89-38B0-876E-A21B-C3218743E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DFE9BB-FB05-DED3-D0FC-CAB28A1CB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927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F2AB88-D7D7-C776-1CBE-BB68DA5BC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92F224-D5ED-4859-0F01-2C16BD3542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8296A7-3AA2-2FBD-2186-2C6DEABEA9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DD7B4-AEF1-404E-A90B-C7D13B4A452E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7DDA30-24C8-B4EE-AB5D-3057207CD1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51F9AA-0C47-FD52-9E09-EDDE029896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9CDC2-2A70-CB4B-85A2-660CC5AE3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760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red and blue device&#10;&#10;Description automatically generated">
            <a:extLst>
              <a:ext uri="{FF2B5EF4-FFF2-40B4-BE49-F238E27FC236}">
                <a16:creationId xmlns:a16="http://schemas.microsoft.com/office/drawing/2014/main" id="{A7FFEE11-A56C-553A-6E27-056446311CE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82848" y="2885768"/>
            <a:ext cx="3962400" cy="29233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A358DC2-BAEE-976F-EFB6-96CA876E521F}"/>
              </a:ext>
            </a:extLst>
          </p:cNvPr>
          <p:cNvSpPr txBox="1"/>
          <p:nvPr/>
        </p:nvSpPr>
        <p:spPr>
          <a:xfrm>
            <a:off x="3386083" y="695430"/>
            <a:ext cx="52331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2B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same samples run in different order)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F4FEF122-F821-AAAF-8516-C81D2F7255DB}"/>
              </a:ext>
            </a:extLst>
          </p:cNvPr>
          <p:cNvSpPr/>
          <p:nvPr/>
        </p:nvSpPr>
        <p:spPr>
          <a:xfrm rot="16200000">
            <a:off x="4984634" y="2383192"/>
            <a:ext cx="287480" cy="717666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ight Brace 7">
            <a:extLst>
              <a:ext uri="{FF2B5EF4-FFF2-40B4-BE49-F238E27FC236}">
                <a16:creationId xmlns:a16="http://schemas.microsoft.com/office/drawing/2014/main" id="{E9F2BA3C-E9D6-E01E-05AE-577A6CDBE98C}"/>
              </a:ext>
            </a:extLst>
          </p:cNvPr>
          <p:cNvSpPr/>
          <p:nvPr/>
        </p:nvSpPr>
        <p:spPr>
          <a:xfrm rot="16200000">
            <a:off x="5756333" y="2385271"/>
            <a:ext cx="287480" cy="717664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EFF094-C66B-0903-13D4-2A6ED5FEC6D4}"/>
              </a:ext>
            </a:extLst>
          </p:cNvPr>
          <p:cNvSpPr txBox="1"/>
          <p:nvPr/>
        </p:nvSpPr>
        <p:spPr>
          <a:xfrm rot="18811416">
            <a:off x="4678376" y="1889229"/>
            <a:ext cx="1785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33A (samples 1-3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EBE823-C684-26C3-EE62-98DED827B79F}"/>
              </a:ext>
            </a:extLst>
          </p:cNvPr>
          <p:cNvSpPr txBox="1"/>
          <p:nvPr/>
        </p:nvSpPr>
        <p:spPr>
          <a:xfrm rot="18664967">
            <a:off x="5434712" y="1848871"/>
            <a:ext cx="17956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L33B (samples 1-3)</a:t>
            </a:r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402E0473-DE74-9A1A-6EAB-C4041E55F51A}"/>
              </a:ext>
            </a:extLst>
          </p:cNvPr>
          <p:cNvSpPr/>
          <p:nvPr/>
        </p:nvSpPr>
        <p:spPr>
          <a:xfrm rot="16200000">
            <a:off x="4417168" y="2623689"/>
            <a:ext cx="284707" cy="239443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832F4A8B-2C02-D72C-7838-021F81128FB6}"/>
              </a:ext>
            </a:extLst>
          </p:cNvPr>
          <p:cNvSpPr/>
          <p:nvPr/>
        </p:nvSpPr>
        <p:spPr>
          <a:xfrm rot="16200000">
            <a:off x="4123691" y="2623689"/>
            <a:ext cx="284707" cy="239443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F2F98E-F1F4-B40E-1C92-FCBE63663801}"/>
              </a:ext>
            </a:extLst>
          </p:cNvPr>
          <p:cNvSpPr txBox="1"/>
          <p:nvPr/>
        </p:nvSpPr>
        <p:spPr>
          <a:xfrm rot="18664967">
            <a:off x="4154946" y="1771763"/>
            <a:ext cx="16658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soform standard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ll, d4, d34, d34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B5A0C7-3427-E21D-2B7E-8E0CE788777D}"/>
              </a:ext>
            </a:extLst>
          </p:cNvPr>
          <p:cNvSpPr txBox="1"/>
          <p:nvPr/>
        </p:nvSpPr>
        <p:spPr>
          <a:xfrm rot="18664967">
            <a:off x="4006403" y="2158363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09E2CD-FDE6-BF88-BAB6-EC2111F08DAD}"/>
              </a:ext>
            </a:extLst>
          </p:cNvPr>
          <p:cNvSpPr txBox="1"/>
          <p:nvPr/>
        </p:nvSpPr>
        <p:spPr>
          <a:xfrm>
            <a:off x="3953001" y="462746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1ED2FA0-943C-3294-E310-051111FDD7DF}"/>
              </a:ext>
            </a:extLst>
          </p:cNvPr>
          <p:cNvSpPr txBox="1"/>
          <p:nvPr/>
        </p:nvSpPr>
        <p:spPr>
          <a:xfrm>
            <a:off x="3953001" y="453319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C3239F-5EE8-6220-4931-0F789B5BACC0}"/>
              </a:ext>
            </a:extLst>
          </p:cNvPr>
          <p:cNvSpPr txBox="1"/>
          <p:nvPr/>
        </p:nvSpPr>
        <p:spPr>
          <a:xfrm>
            <a:off x="3953001" y="443893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9FC00D-9715-31BE-2FC6-E45DA14E7459}"/>
              </a:ext>
            </a:extLst>
          </p:cNvPr>
          <p:cNvSpPr txBox="1"/>
          <p:nvPr/>
        </p:nvSpPr>
        <p:spPr>
          <a:xfrm>
            <a:off x="3949647" y="434466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95E3BD-7D7B-1804-7A2C-526042EF3291}"/>
              </a:ext>
            </a:extLst>
          </p:cNvPr>
          <p:cNvSpPr txBox="1"/>
          <p:nvPr/>
        </p:nvSpPr>
        <p:spPr>
          <a:xfrm>
            <a:off x="3945686" y="423694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922074-5345-BCE8-BB77-339F4729DFD0}"/>
              </a:ext>
            </a:extLst>
          </p:cNvPr>
          <p:cNvSpPr txBox="1"/>
          <p:nvPr/>
        </p:nvSpPr>
        <p:spPr>
          <a:xfrm>
            <a:off x="3895293" y="4128898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0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8977289-B32E-3956-735B-B466A9D8510F}"/>
              </a:ext>
            </a:extLst>
          </p:cNvPr>
          <p:cNvSpPr txBox="1"/>
          <p:nvPr/>
        </p:nvSpPr>
        <p:spPr>
          <a:xfrm>
            <a:off x="3882848" y="4019188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0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025B932-0617-7735-1F6E-9489548849CB}"/>
              </a:ext>
            </a:extLst>
          </p:cNvPr>
          <p:cNvSpPr txBox="1"/>
          <p:nvPr/>
        </p:nvSpPr>
        <p:spPr>
          <a:xfrm>
            <a:off x="3877718" y="3900098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0 </a:t>
            </a:r>
          </a:p>
        </p:txBody>
      </p:sp>
    </p:spTree>
    <p:extLst>
      <p:ext uri="{BB962C8B-B14F-4D97-AF65-F5344CB8AC3E}">
        <p14:creationId xmlns:p14="http://schemas.microsoft.com/office/powerpoint/2010/main" val="1874667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square with black spots&#10;&#10;Description automatically generated">
            <a:extLst>
              <a:ext uri="{FF2B5EF4-FFF2-40B4-BE49-F238E27FC236}">
                <a16:creationId xmlns:a16="http://schemas.microsoft.com/office/drawing/2014/main" id="{5DF55BCE-49D4-D25E-6E22-30FB6C48DDA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83579" y="2446590"/>
            <a:ext cx="3672348" cy="355436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556E67A-4F1E-277A-6EB7-8EBEECBE64F7}"/>
              </a:ext>
            </a:extLst>
          </p:cNvPr>
          <p:cNvSpPr txBox="1"/>
          <p:nvPr/>
        </p:nvSpPr>
        <p:spPr>
          <a:xfrm>
            <a:off x="3744003" y="601588"/>
            <a:ext cx="35060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3E</a:t>
            </a: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01CCABC0-033A-7F0B-AE98-104B0591B9BF}"/>
              </a:ext>
            </a:extLst>
          </p:cNvPr>
          <p:cNvSpPr/>
          <p:nvPr/>
        </p:nvSpPr>
        <p:spPr>
          <a:xfrm rot="16200000">
            <a:off x="2919218" y="2278574"/>
            <a:ext cx="297581" cy="52500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ight Brace 7">
            <a:extLst>
              <a:ext uri="{FF2B5EF4-FFF2-40B4-BE49-F238E27FC236}">
                <a16:creationId xmlns:a16="http://schemas.microsoft.com/office/drawing/2014/main" id="{21D660AE-CB83-C45E-15A1-2625784F908F}"/>
              </a:ext>
            </a:extLst>
          </p:cNvPr>
          <p:cNvSpPr/>
          <p:nvPr/>
        </p:nvSpPr>
        <p:spPr>
          <a:xfrm rot="16200000">
            <a:off x="3509476" y="2269436"/>
            <a:ext cx="297581" cy="547439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B331A3-3501-8C62-14CC-6BBEA051DB67}"/>
              </a:ext>
            </a:extLst>
          </p:cNvPr>
          <p:cNvSpPr txBox="1"/>
          <p:nvPr/>
        </p:nvSpPr>
        <p:spPr>
          <a:xfrm rot="18811416">
            <a:off x="2743097" y="1719500"/>
            <a:ext cx="14187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2B 0, 6, 12 hr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080EF3-4AC9-053D-EEEE-8045C10BDEFE}"/>
              </a:ext>
            </a:extLst>
          </p:cNvPr>
          <p:cNvSpPr txBox="1"/>
          <p:nvPr/>
        </p:nvSpPr>
        <p:spPr>
          <a:xfrm rot="18664967">
            <a:off x="3300917" y="1673486"/>
            <a:ext cx="1647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6HBE 0, 6, 12 hr.</a:t>
            </a:r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3B0EF61D-330E-B3FC-B77C-12DC93921E15}"/>
              </a:ext>
            </a:extLst>
          </p:cNvPr>
          <p:cNvSpPr/>
          <p:nvPr/>
        </p:nvSpPr>
        <p:spPr>
          <a:xfrm rot="16200000">
            <a:off x="2374934" y="2303231"/>
            <a:ext cx="284708" cy="468364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278EED49-A0CC-1F8F-FCC0-32394391B4CA}"/>
              </a:ext>
            </a:extLst>
          </p:cNvPr>
          <p:cNvSpPr/>
          <p:nvPr/>
        </p:nvSpPr>
        <p:spPr>
          <a:xfrm rot="16200000">
            <a:off x="1966997" y="2417692"/>
            <a:ext cx="284707" cy="239443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6C44B3-2395-1597-FE5C-270EB3AC7905}"/>
              </a:ext>
            </a:extLst>
          </p:cNvPr>
          <p:cNvSpPr txBox="1"/>
          <p:nvPr/>
        </p:nvSpPr>
        <p:spPr>
          <a:xfrm rot="18664967">
            <a:off x="2106586" y="1673487"/>
            <a:ext cx="14491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BE 0, 6, 12 hr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E4A2F4-A23E-9C91-BF4B-501B2D828CAC}"/>
              </a:ext>
            </a:extLst>
          </p:cNvPr>
          <p:cNvSpPr txBox="1"/>
          <p:nvPr/>
        </p:nvSpPr>
        <p:spPr>
          <a:xfrm rot="18664967">
            <a:off x="1849709" y="1952366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437314-FF2B-C711-2EB6-07ABB34A1FB8}"/>
              </a:ext>
            </a:extLst>
          </p:cNvPr>
          <p:cNvSpPr txBox="1"/>
          <p:nvPr/>
        </p:nvSpPr>
        <p:spPr>
          <a:xfrm>
            <a:off x="1989629" y="430590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101589-6837-4B06-B46D-F31BE426874D}"/>
              </a:ext>
            </a:extLst>
          </p:cNvPr>
          <p:cNvSpPr txBox="1"/>
          <p:nvPr/>
        </p:nvSpPr>
        <p:spPr>
          <a:xfrm>
            <a:off x="1989629" y="402563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11647F-1D36-2AB8-344F-65E78F82B166}"/>
              </a:ext>
            </a:extLst>
          </p:cNvPr>
          <p:cNvSpPr txBox="1"/>
          <p:nvPr/>
        </p:nvSpPr>
        <p:spPr>
          <a:xfrm>
            <a:off x="1989629" y="38684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8 </a:t>
            </a:r>
          </a:p>
        </p:txBody>
      </p:sp>
      <p:pic>
        <p:nvPicPr>
          <p:cNvPr id="3" name="Picture 2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ECA0FC46-7752-5EDC-41E4-27A987D6301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38922" y="3337232"/>
            <a:ext cx="3594100" cy="20193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71DA3AB-F5AE-7C12-1C5F-A1C328F0C142}"/>
              </a:ext>
            </a:extLst>
          </p:cNvPr>
          <p:cNvSpPr txBox="1"/>
          <p:nvPr/>
        </p:nvSpPr>
        <p:spPr>
          <a:xfrm>
            <a:off x="5221400" y="2679767"/>
            <a:ext cx="34291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ame blot, higher resolution image and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ower level exposure as shown in Fig. 3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759E2D-24E2-154A-D240-986A773A787E}"/>
              </a:ext>
            </a:extLst>
          </p:cNvPr>
          <p:cNvSpPr txBox="1"/>
          <p:nvPr/>
        </p:nvSpPr>
        <p:spPr>
          <a:xfrm>
            <a:off x="5316549" y="478136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984826-75C0-98AA-D906-CC31BF897F44}"/>
              </a:ext>
            </a:extLst>
          </p:cNvPr>
          <p:cNvSpPr txBox="1"/>
          <p:nvPr/>
        </p:nvSpPr>
        <p:spPr>
          <a:xfrm>
            <a:off x="5316549" y="440089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08C1E79-E402-8E44-F4B6-FE64D9520489}"/>
              </a:ext>
            </a:extLst>
          </p:cNvPr>
          <p:cNvSpPr txBox="1"/>
          <p:nvPr/>
        </p:nvSpPr>
        <p:spPr>
          <a:xfrm>
            <a:off x="5308240" y="419152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8 </a:t>
            </a:r>
          </a:p>
        </p:txBody>
      </p:sp>
    </p:spTree>
    <p:extLst>
      <p:ext uri="{BB962C8B-B14F-4D97-AF65-F5344CB8AC3E}">
        <p14:creationId xmlns:p14="http://schemas.microsoft.com/office/powerpoint/2010/main" val="3612919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76DB02-1497-0C18-1554-60E245244E11}"/>
              </a:ext>
            </a:extLst>
          </p:cNvPr>
          <p:cNvSpPr txBox="1"/>
          <p:nvPr/>
        </p:nvSpPr>
        <p:spPr>
          <a:xfrm>
            <a:off x="4045304" y="370255"/>
            <a:ext cx="3493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4F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9C16450-2CAB-2320-5481-79B0D928736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7386" y="2907642"/>
            <a:ext cx="2593026" cy="2219258"/>
          </a:xfrm>
          <a:prstGeom prst="rect">
            <a:avLst/>
          </a:prstGeom>
        </p:spPr>
      </p:pic>
      <p:pic>
        <p:nvPicPr>
          <p:cNvPr id="8" name="Picture 7" descr="A close-up of a white square&#10;&#10;Description automatically generated">
            <a:extLst>
              <a:ext uri="{FF2B5EF4-FFF2-40B4-BE49-F238E27FC236}">
                <a16:creationId xmlns:a16="http://schemas.microsoft.com/office/drawing/2014/main" id="{2DC948FB-BF17-E43E-ADB7-6CE134A5516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39076" y="2901389"/>
            <a:ext cx="2593027" cy="2219258"/>
          </a:xfrm>
          <a:prstGeom prst="rect">
            <a:avLst/>
          </a:prstGeom>
        </p:spPr>
      </p:pic>
      <p:pic>
        <p:nvPicPr>
          <p:cNvPr id="10" name="Picture 9" descr="A white paper with black spots on it&#10;&#10;Description automatically generated">
            <a:extLst>
              <a:ext uri="{FF2B5EF4-FFF2-40B4-BE49-F238E27FC236}">
                <a16:creationId xmlns:a16="http://schemas.microsoft.com/office/drawing/2014/main" id="{36F509B2-11D3-A635-34D8-4ADFDC53B47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107540" y="2901389"/>
            <a:ext cx="2831464" cy="2219258"/>
          </a:xfrm>
          <a:prstGeom prst="rect">
            <a:avLst/>
          </a:prstGeom>
        </p:spPr>
      </p:pic>
      <p:sp>
        <p:nvSpPr>
          <p:cNvPr id="2" name="Right Brace 1">
            <a:extLst>
              <a:ext uri="{FF2B5EF4-FFF2-40B4-BE49-F238E27FC236}">
                <a16:creationId xmlns:a16="http://schemas.microsoft.com/office/drawing/2014/main" id="{ADD5A9A0-9078-33C2-7BD9-3AB59BD9D246}"/>
              </a:ext>
            </a:extLst>
          </p:cNvPr>
          <p:cNvSpPr/>
          <p:nvPr/>
        </p:nvSpPr>
        <p:spPr>
          <a:xfrm rot="16200000">
            <a:off x="1793628" y="2644013"/>
            <a:ext cx="313016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6139F4-8822-228D-76AA-2D862D7615E5}"/>
              </a:ext>
            </a:extLst>
          </p:cNvPr>
          <p:cNvSpPr txBox="1"/>
          <p:nvPr/>
        </p:nvSpPr>
        <p:spPr>
          <a:xfrm rot="18811416">
            <a:off x="1581526" y="1841152"/>
            <a:ext cx="1674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-/+ PMA</a:t>
            </a:r>
          </a:p>
        </p:txBody>
      </p:sp>
      <p:sp>
        <p:nvSpPr>
          <p:cNvPr id="5" name="Right Brace 4">
            <a:extLst>
              <a:ext uri="{FF2B5EF4-FFF2-40B4-BE49-F238E27FC236}">
                <a16:creationId xmlns:a16="http://schemas.microsoft.com/office/drawing/2014/main" id="{851EDE13-E134-7A35-39A3-DEE308CD7C34}"/>
              </a:ext>
            </a:extLst>
          </p:cNvPr>
          <p:cNvSpPr/>
          <p:nvPr/>
        </p:nvSpPr>
        <p:spPr>
          <a:xfrm rot="16200000">
            <a:off x="1378861" y="2496048"/>
            <a:ext cx="281293" cy="527326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75AA400C-C923-EFF8-191C-90F4E5D30D2A}"/>
              </a:ext>
            </a:extLst>
          </p:cNvPr>
          <p:cNvSpPr/>
          <p:nvPr/>
        </p:nvSpPr>
        <p:spPr>
          <a:xfrm rot="16200000">
            <a:off x="970913" y="2652221"/>
            <a:ext cx="286937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7751E1-4126-9078-C62E-EFB1853095F8}"/>
              </a:ext>
            </a:extLst>
          </p:cNvPr>
          <p:cNvSpPr txBox="1"/>
          <p:nvPr/>
        </p:nvSpPr>
        <p:spPr>
          <a:xfrm rot="18664967">
            <a:off x="845330" y="2178985"/>
            <a:ext cx="746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8755833E-65A0-CEB6-42AD-F891B367D67D}"/>
              </a:ext>
            </a:extLst>
          </p:cNvPr>
          <p:cNvSpPr/>
          <p:nvPr/>
        </p:nvSpPr>
        <p:spPr>
          <a:xfrm rot="16200000">
            <a:off x="2828274" y="2688207"/>
            <a:ext cx="286937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110130-DC5C-FF68-2CE5-F63C7767C743}"/>
              </a:ext>
            </a:extLst>
          </p:cNvPr>
          <p:cNvSpPr txBox="1"/>
          <p:nvPr/>
        </p:nvSpPr>
        <p:spPr>
          <a:xfrm rot="18664967">
            <a:off x="2710963" y="2221098"/>
            <a:ext cx="746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190D6EA8-F0CC-2603-9024-6C365FB4CE5D}"/>
              </a:ext>
            </a:extLst>
          </p:cNvPr>
          <p:cNvSpPr/>
          <p:nvPr/>
        </p:nvSpPr>
        <p:spPr>
          <a:xfrm rot="16200000">
            <a:off x="3600432" y="2678105"/>
            <a:ext cx="286937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B68937-D0DF-D347-D586-C437A9DEF4F6}"/>
              </a:ext>
            </a:extLst>
          </p:cNvPr>
          <p:cNvSpPr txBox="1"/>
          <p:nvPr/>
        </p:nvSpPr>
        <p:spPr>
          <a:xfrm rot="18664967">
            <a:off x="3483121" y="2210996"/>
            <a:ext cx="746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5" name="Right Brace 14">
            <a:extLst>
              <a:ext uri="{FF2B5EF4-FFF2-40B4-BE49-F238E27FC236}">
                <a16:creationId xmlns:a16="http://schemas.microsoft.com/office/drawing/2014/main" id="{A0207AA8-9C5B-BD55-DEBC-29C84A8EEC06}"/>
              </a:ext>
            </a:extLst>
          </p:cNvPr>
          <p:cNvSpPr/>
          <p:nvPr/>
        </p:nvSpPr>
        <p:spPr>
          <a:xfrm rot="16200000">
            <a:off x="5471687" y="2669068"/>
            <a:ext cx="286937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132049-54AF-7E7D-E1C2-05B8F1610FFF}"/>
              </a:ext>
            </a:extLst>
          </p:cNvPr>
          <p:cNvSpPr txBox="1"/>
          <p:nvPr/>
        </p:nvSpPr>
        <p:spPr>
          <a:xfrm rot="18664967">
            <a:off x="5354376" y="2201959"/>
            <a:ext cx="746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7" name="Right Brace 16">
            <a:extLst>
              <a:ext uri="{FF2B5EF4-FFF2-40B4-BE49-F238E27FC236}">
                <a16:creationId xmlns:a16="http://schemas.microsoft.com/office/drawing/2014/main" id="{8028DF16-D3F2-710B-8446-3EA9AB2161B0}"/>
              </a:ext>
            </a:extLst>
          </p:cNvPr>
          <p:cNvSpPr/>
          <p:nvPr/>
        </p:nvSpPr>
        <p:spPr>
          <a:xfrm rot="16200000">
            <a:off x="6238871" y="2697438"/>
            <a:ext cx="286937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09709A-7FFC-1D4D-BC01-410F69CC2C58}"/>
              </a:ext>
            </a:extLst>
          </p:cNvPr>
          <p:cNvSpPr txBox="1"/>
          <p:nvPr/>
        </p:nvSpPr>
        <p:spPr>
          <a:xfrm rot="18664967">
            <a:off x="5700293" y="1304174"/>
            <a:ext cx="32041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rker (w/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hem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+control)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37A319EF-6A69-1A52-00C2-E8BF2603F85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14440" y="2901389"/>
            <a:ext cx="2846577" cy="2219258"/>
          </a:xfrm>
          <a:prstGeom prst="rect">
            <a:avLst/>
          </a:prstGeom>
        </p:spPr>
      </p:pic>
      <p:sp>
        <p:nvSpPr>
          <p:cNvPr id="23" name="Right Brace 22">
            <a:extLst>
              <a:ext uri="{FF2B5EF4-FFF2-40B4-BE49-F238E27FC236}">
                <a16:creationId xmlns:a16="http://schemas.microsoft.com/office/drawing/2014/main" id="{BB5E280E-A41C-E8E3-AB3D-641227552676}"/>
              </a:ext>
            </a:extLst>
          </p:cNvPr>
          <p:cNvSpPr/>
          <p:nvPr/>
        </p:nvSpPr>
        <p:spPr>
          <a:xfrm rot="16200000">
            <a:off x="2044428" y="2659715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18BF3C-DD8D-1B4D-11F2-F29F9CEDBD90}"/>
              </a:ext>
            </a:extLst>
          </p:cNvPr>
          <p:cNvSpPr txBox="1"/>
          <p:nvPr/>
        </p:nvSpPr>
        <p:spPr>
          <a:xfrm rot="18664967">
            <a:off x="1200690" y="2102600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nrelated</a:t>
            </a:r>
          </a:p>
        </p:txBody>
      </p:sp>
      <p:sp>
        <p:nvSpPr>
          <p:cNvPr id="25" name="Right Brace 24">
            <a:extLst>
              <a:ext uri="{FF2B5EF4-FFF2-40B4-BE49-F238E27FC236}">
                <a16:creationId xmlns:a16="http://schemas.microsoft.com/office/drawing/2014/main" id="{C6D1D5F1-AF0D-F2F6-AFF1-24AEE605D2A9}"/>
              </a:ext>
            </a:extLst>
          </p:cNvPr>
          <p:cNvSpPr/>
          <p:nvPr/>
        </p:nvSpPr>
        <p:spPr>
          <a:xfrm rot="16200000">
            <a:off x="2281989" y="2654887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ight Brace 25">
            <a:extLst>
              <a:ext uri="{FF2B5EF4-FFF2-40B4-BE49-F238E27FC236}">
                <a16:creationId xmlns:a16="http://schemas.microsoft.com/office/drawing/2014/main" id="{DB5C76A1-9EC8-4DE2-9793-6377C9DC35F8}"/>
              </a:ext>
            </a:extLst>
          </p:cNvPr>
          <p:cNvSpPr/>
          <p:nvPr/>
        </p:nvSpPr>
        <p:spPr>
          <a:xfrm rot="16200000">
            <a:off x="2517056" y="2654886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01DF2B0-D9A0-AB8C-13C1-A98090569C87}"/>
              </a:ext>
            </a:extLst>
          </p:cNvPr>
          <p:cNvSpPr txBox="1"/>
          <p:nvPr/>
        </p:nvSpPr>
        <p:spPr>
          <a:xfrm rot="18811416">
            <a:off x="1708851" y="1606355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A RNAi -/+ PM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3B24917-7D4F-4CFF-16F4-99DF56BB4195}"/>
              </a:ext>
            </a:extLst>
          </p:cNvPr>
          <p:cNvSpPr txBox="1"/>
          <p:nvPr/>
        </p:nvSpPr>
        <p:spPr>
          <a:xfrm rot="18811416">
            <a:off x="1977336" y="1613640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C RNAi -/+ PM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AE1313-FDD8-292A-EFE3-2BD4576FD7B5}"/>
              </a:ext>
            </a:extLst>
          </p:cNvPr>
          <p:cNvSpPr txBox="1"/>
          <p:nvPr/>
        </p:nvSpPr>
        <p:spPr>
          <a:xfrm rot="18811416">
            <a:off x="2222534" y="1620925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JUN RNAi -/+ PMA</a:t>
            </a:r>
          </a:p>
        </p:txBody>
      </p:sp>
      <p:sp>
        <p:nvSpPr>
          <p:cNvPr id="30" name="Right Brace 29">
            <a:extLst>
              <a:ext uri="{FF2B5EF4-FFF2-40B4-BE49-F238E27FC236}">
                <a16:creationId xmlns:a16="http://schemas.microsoft.com/office/drawing/2014/main" id="{C5A1BF94-8407-892B-C997-450465AC78A8}"/>
              </a:ext>
            </a:extLst>
          </p:cNvPr>
          <p:cNvSpPr/>
          <p:nvPr/>
        </p:nvSpPr>
        <p:spPr>
          <a:xfrm rot="16200000">
            <a:off x="4444853" y="2636864"/>
            <a:ext cx="313016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88049D2-F8BA-3AFC-3148-D30EA504E360}"/>
              </a:ext>
            </a:extLst>
          </p:cNvPr>
          <p:cNvSpPr txBox="1"/>
          <p:nvPr/>
        </p:nvSpPr>
        <p:spPr>
          <a:xfrm rot="18811416">
            <a:off x="4232751" y="1834003"/>
            <a:ext cx="1674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-/+ PMA</a:t>
            </a:r>
          </a:p>
        </p:txBody>
      </p:sp>
      <p:sp>
        <p:nvSpPr>
          <p:cNvPr id="32" name="Right Brace 31">
            <a:extLst>
              <a:ext uri="{FF2B5EF4-FFF2-40B4-BE49-F238E27FC236}">
                <a16:creationId xmlns:a16="http://schemas.microsoft.com/office/drawing/2014/main" id="{92785115-086C-6A62-9BC5-2820D4226CB3}"/>
              </a:ext>
            </a:extLst>
          </p:cNvPr>
          <p:cNvSpPr/>
          <p:nvPr/>
        </p:nvSpPr>
        <p:spPr>
          <a:xfrm rot="16200000">
            <a:off x="4030086" y="2488899"/>
            <a:ext cx="281293" cy="527326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ight Brace 34">
            <a:extLst>
              <a:ext uri="{FF2B5EF4-FFF2-40B4-BE49-F238E27FC236}">
                <a16:creationId xmlns:a16="http://schemas.microsoft.com/office/drawing/2014/main" id="{614E28A3-D181-6F0E-EE81-DA583308087B}"/>
              </a:ext>
            </a:extLst>
          </p:cNvPr>
          <p:cNvSpPr/>
          <p:nvPr/>
        </p:nvSpPr>
        <p:spPr>
          <a:xfrm rot="16200000">
            <a:off x="4695653" y="2652566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ACA287E-895B-A8C2-C0CA-8EA3A1E60029}"/>
              </a:ext>
            </a:extLst>
          </p:cNvPr>
          <p:cNvSpPr txBox="1"/>
          <p:nvPr/>
        </p:nvSpPr>
        <p:spPr>
          <a:xfrm rot="18664967">
            <a:off x="3851915" y="2095451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nrelated</a:t>
            </a:r>
          </a:p>
        </p:txBody>
      </p:sp>
      <p:sp>
        <p:nvSpPr>
          <p:cNvPr id="37" name="Right Brace 36">
            <a:extLst>
              <a:ext uri="{FF2B5EF4-FFF2-40B4-BE49-F238E27FC236}">
                <a16:creationId xmlns:a16="http://schemas.microsoft.com/office/drawing/2014/main" id="{C7527931-F214-1504-093A-8F849D884742}"/>
              </a:ext>
            </a:extLst>
          </p:cNvPr>
          <p:cNvSpPr/>
          <p:nvPr/>
        </p:nvSpPr>
        <p:spPr>
          <a:xfrm rot="16200000">
            <a:off x="4933214" y="2647738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ight Brace 37">
            <a:extLst>
              <a:ext uri="{FF2B5EF4-FFF2-40B4-BE49-F238E27FC236}">
                <a16:creationId xmlns:a16="http://schemas.microsoft.com/office/drawing/2014/main" id="{A57B54DE-52E5-7E93-869E-9ED4778B3208}"/>
              </a:ext>
            </a:extLst>
          </p:cNvPr>
          <p:cNvSpPr/>
          <p:nvPr/>
        </p:nvSpPr>
        <p:spPr>
          <a:xfrm rot="16200000">
            <a:off x="5168281" y="2647737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31F2BCD-1A07-1350-F9BB-A5B9B4C43A16}"/>
              </a:ext>
            </a:extLst>
          </p:cNvPr>
          <p:cNvSpPr txBox="1"/>
          <p:nvPr/>
        </p:nvSpPr>
        <p:spPr>
          <a:xfrm rot="18811416">
            <a:off x="4364339" y="1629230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A RNAi -/+ PM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8138AD8-0C9E-0AA5-1C3D-122DF231273E}"/>
              </a:ext>
            </a:extLst>
          </p:cNvPr>
          <p:cNvSpPr txBox="1"/>
          <p:nvPr/>
        </p:nvSpPr>
        <p:spPr>
          <a:xfrm rot="18811416">
            <a:off x="4632824" y="1636515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C RNAi -/+ PM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283CA04-76EC-CCE7-716E-23162BFC839D}"/>
              </a:ext>
            </a:extLst>
          </p:cNvPr>
          <p:cNvSpPr txBox="1"/>
          <p:nvPr/>
        </p:nvSpPr>
        <p:spPr>
          <a:xfrm rot="18811416">
            <a:off x="4878022" y="1643800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JUN RNAi -/+ PMA</a:t>
            </a:r>
          </a:p>
        </p:txBody>
      </p:sp>
      <p:sp>
        <p:nvSpPr>
          <p:cNvPr id="42" name="Right Brace 41">
            <a:extLst>
              <a:ext uri="{FF2B5EF4-FFF2-40B4-BE49-F238E27FC236}">
                <a16:creationId xmlns:a16="http://schemas.microsoft.com/office/drawing/2014/main" id="{92A2BB79-ABFC-A248-2960-22ADB470220F}"/>
              </a:ext>
            </a:extLst>
          </p:cNvPr>
          <p:cNvSpPr/>
          <p:nvPr/>
        </p:nvSpPr>
        <p:spPr>
          <a:xfrm rot="16200000">
            <a:off x="6798765" y="2660857"/>
            <a:ext cx="313016" cy="230277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5CE877E-2189-C544-FC32-67CAE8FE0CAF}"/>
              </a:ext>
            </a:extLst>
          </p:cNvPr>
          <p:cNvSpPr txBox="1"/>
          <p:nvPr/>
        </p:nvSpPr>
        <p:spPr>
          <a:xfrm rot="18811416">
            <a:off x="6586663" y="1857996"/>
            <a:ext cx="1674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-/+ PMA</a:t>
            </a:r>
          </a:p>
        </p:txBody>
      </p:sp>
      <p:sp>
        <p:nvSpPr>
          <p:cNvPr id="49" name="Right Brace 48">
            <a:extLst>
              <a:ext uri="{FF2B5EF4-FFF2-40B4-BE49-F238E27FC236}">
                <a16:creationId xmlns:a16="http://schemas.microsoft.com/office/drawing/2014/main" id="{9AF2D0DD-8FFC-6491-FBE0-EBD67303EEAB}"/>
              </a:ext>
            </a:extLst>
          </p:cNvPr>
          <p:cNvSpPr/>
          <p:nvPr/>
        </p:nvSpPr>
        <p:spPr>
          <a:xfrm rot="16200000">
            <a:off x="7273967" y="2676560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ight Brace 50">
            <a:extLst>
              <a:ext uri="{FF2B5EF4-FFF2-40B4-BE49-F238E27FC236}">
                <a16:creationId xmlns:a16="http://schemas.microsoft.com/office/drawing/2014/main" id="{F3A9D55E-3983-777E-34CD-00524A703603}"/>
              </a:ext>
            </a:extLst>
          </p:cNvPr>
          <p:cNvSpPr/>
          <p:nvPr/>
        </p:nvSpPr>
        <p:spPr>
          <a:xfrm rot="16200000">
            <a:off x="7690321" y="2659715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ight Brace 51">
            <a:extLst>
              <a:ext uri="{FF2B5EF4-FFF2-40B4-BE49-F238E27FC236}">
                <a16:creationId xmlns:a16="http://schemas.microsoft.com/office/drawing/2014/main" id="{8E85392C-A259-9102-B96D-10245630E309}"/>
              </a:ext>
            </a:extLst>
          </p:cNvPr>
          <p:cNvSpPr/>
          <p:nvPr/>
        </p:nvSpPr>
        <p:spPr>
          <a:xfrm rot="16200000">
            <a:off x="8116799" y="2639788"/>
            <a:ext cx="296597" cy="215291"/>
          </a:xfrm>
          <a:prstGeom prst="righ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E182192-9D32-C4C5-8ACC-E29492435508}"/>
              </a:ext>
            </a:extLst>
          </p:cNvPr>
          <p:cNvSpPr txBox="1"/>
          <p:nvPr/>
        </p:nvSpPr>
        <p:spPr>
          <a:xfrm rot="18811416">
            <a:off x="6969559" y="1652859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A RNAi -/+ PM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6FBCE3E-BF91-A50E-8AF5-F729AAFA8AB4}"/>
              </a:ext>
            </a:extLst>
          </p:cNvPr>
          <p:cNvSpPr txBox="1"/>
          <p:nvPr/>
        </p:nvSpPr>
        <p:spPr>
          <a:xfrm rot="18811416">
            <a:off x="7432929" y="1665853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2C RNAi -/+ PM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92D542D-D334-2552-577A-A0B83E51FC4B}"/>
              </a:ext>
            </a:extLst>
          </p:cNvPr>
          <p:cNvSpPr txBox="1"/>
          <p:nvPr/>
        </p:nvSpPr>
        <p:spPr>
          <a:xfrm rot="18811416">
            <a:off x="7886470" y="1678705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JUN RNAi -/+ PM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7C4BF81-2718-C929-EFC4-BBF72B2B1CCF}"/>
              </a:ext>
            </a:extLst>
          </p:cNvPr>
          <p:cNvSpPr txBox="1"/>
          <p:nvPr/>
        </p:nvSpPr>
        <p:spPr>
          <a:xfrm>
            <a:off x="9466911" y="3777669"/>
            <a:ext cx="23081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embrane only, no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hemi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969A9834-4791-8B4D-142C-5440CF1B5E33}"/>
              </a:ext>
            </a:extLst>
          </p:cNvPr>
          <p:cNvCxnSpPr/>
          <p:nvPr/>
        </p:nvCxnSpPr>
        <p:spPr>
          <a:xfrm>
            <a:off x="8471156" y="3429000"/>
            <a:ext cx="124700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 58">
            <a:extLst>
              <a:ext uri="{FF2B5EF4-FFF2-40B4-BE49-F238E27FC236}">
                <a16:creationId xmlns:a16="http://schemas.microsoft.com/office/drawing/2014/main" id="{34695B20-DB8D-906C-7033-854DD172FC90}"/>
              </a:ext>
            </a:extLst>
          </p:cNvPr>
          <p:cNvSpPr/>
          <p:nvPr/>
        </p:nvSpPr>
        <p:spPr>
          <a:xfrm>
            <a:off x="6735772" y="4306186"/>
            <a:ext cx="1851238" cy="2020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43D0934-D9D3-14F6-ABD8-28A1B5F8EBC2}"/>
              </a:ext>
            </a:extLst>
          </p:cNvPr>
          <p:cNvSpPr txBox="1"/>
          <p:nvPr/>
        </p:nvSpPr>
        <p:spPr>
          <a:xfrm>
            <a:off x="6424765" y="5174338"/>
            <a:ext cx="310676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n-specific band at 17kda, previously seen in non-IL-33 expressing cell lysates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D7AD9F3D-5161-24AC-B125-8C7F8A03D3DF}"/>
              </a:ext>
            </a:extLst>
          </p:cNvPr>
          <p:cNvSpPr/>
          <p:nvPr/>
        </p:nvSpPr>
        <p:spPr>
          <a:xfrm>
            <a:off x="6262187" y="4306185"/>
            <a:ext cx="339170" cy="1010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F1E5798-67DD-82C8-3D75-6F63DEEF662A}"/>
              </a:ext>
            </a:extLst>
          </p:cNvPr>
          <p:cNvSpPr txBox="1"/>
          <p:nvPr/>
        </p:nvSpPr>
        <p:spPr>
          <a:xfrm>
            <a:off x="6343304" y="4346572"/>
            <a:ext cx="516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93188C6-C932-180A-B1A4-E302CEE49D08}"/>
              </a:ext>
            </a:extLst>
          </p:cNvPr>
          <p:cNvCxnSpPr>
            <a:stCxn id="63" idx="3"/>
          </p:cNvCxnSpPr>
          <p:nvPr/>
        </p:nvCxnSpPr>
        <p:spPr>
          <a:xfrm>
            <a:off x="6859409" y="4500461"/>
            <a:ext cx="0" cy="7732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AE5298C3-6CD9-E727-D6F5-F39817A5CCF1}"/>
              </a:ext>
            </a:extLst>
          </p:cNvPr>
          <p:cNvSpPr txBox="1"/>
          <p:nvPr/>
        </p:nvSpPr>
        <p:spPr>
          <a:xfrm>
            <a:off x="869670" y="404585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497D76-0542-C54D-8716-364B93BCD7B9}"/>
              </a:ext>
            </a:extLst>
          </p:cNvPr>
          <p:cNvSpPr txBox="1"/>
          <p:nvPr/>
        </p:nvSpPr>
        <p:spPr>
          <a:xfrm>
            <a:off x="869670" y="380844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22B8A37-2CD3-9256-7306-7507757A84A7}"/>
              </a:ext>
            </a:extLst>
          </p:cNvPr>
          <p:cNvSpPr txBox="1"/>
          <p:nvPr/>
        </p:nvSpPr>
        <p:spPr>
          <a:xfrm>
            <a:off x="869670" y="364953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8 </a:t>
            </a:r>
          </a:p>
        </p:txBody>
      </p:sp>
    </p:spTree>
    <p:extLst>
      <p:ext uri="{BB962C8B-B14F-4D97-AF65-F5344CB8AC3E}">
        <p14:creationId xmlns:p14="http://schemas.microsoft.com/office/powerpoint/2010/main" val="543441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4</TotalTime>
  <Words>178</Words>
  <Application>Microsoft Office PowerPoint</Application>
  <PresentationFormat>Widescreen</PresentationFormat>
  <Paragraphs>5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, Thomas</dc:creator>
  <cp:lastModifiedBy>Hassan, Ghandi</cp:lastModifiedBy>
  <cp:revision>10</cp:revision>
  <dcterms:created xsi:type="dcterms:W3CDTF">2023-08-13T08:14:00Z</dcterms:created>
  <dcterms:modified xsi:type="dcterms:W3CDTF">2024-01-18T00:37:29Z</dcterms:modified>
</cp:coreProperties>
</file>